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2" autoAdjust="0"/>
    <p:restoredTop sz="86513" autoAdjust="0"/>
  </p:normalViewPr>
  <p:slideViewPr>
    <p:cSldViewPr snapToGrid="0">
      <p:cViewPr varScale="1">
        <p:scale>
          <a:sx n="73" d="100"/>
          <a:sy n="73" d="100"/>
        </p:scale>
        <p:origin x="434" y="-1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AE6134-3FE4-446B-9E3B-CCC56A9B239B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4737BB-1C22-4C1F-ABD0-170E1F2C77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09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5ED9D70-1E21-67D7-5F6C-3461D641E59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EC572854-D666-96E5-4F8F-C0307D7661F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80DE8F0-C3A4-E8B7-1D3D-F47AC94BC06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Supplementary Fig. 1.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Agarose gel electrophoresis of amplicons of positive 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V. alginolyticus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isolates for collagenase gene 737bp, Lane M DNA ladder 100 bp, Lane 1,2,3,4 positive 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V. alginolyticus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. </a:t>
            </a: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0AE1108-B1E4-D53A-B207-DD6CB416EB9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4737BB-1C22-4C1F-ABD0-170E1F2C77D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2059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CD1C21-0DE0-9330-81DE-0AB23D4A92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FBDC05-824A-4C84-3521-AD10AA5544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81CD00-B7D2-34FC-C89A-C85C9D0D4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A01557-5D90-BEED-03D1-26E0A1A7E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B388D9-622F-E7D8-57C6-538B1CE3B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5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C379C-05C9-0277-2554-AFB3945807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2589CA-9796-06E2-877D-EBF587B86C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E944DB-2E6C-9C17-1EFA-03FCA2D73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1E4753-2FE0-8816-9540-1E48D1B4B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88B5BA-3611-53CF-92B5-0424CB7ABB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524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78C6A6-4CA8-6A94-84CF-90ACFA871D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D2166D-7E6C-CFB2-0E30-17013F5339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FCAADD-3EED-1AE6-D9BE-B230D6E3A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C43A32-F4B6-60C7-7E82-770045EDF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C97EFA-E2D5-BFAC-452F-27729EC961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34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B8E60C-D205-A191-1D98-82CF439E57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5A8C5E-ED45-A182-2261-81139F8FDC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8900D0-C646-8033-BFAA-656AF9A838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4D64B6-7F58-97F4-5F11-FC2A92E4C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8C9EC9-E9BD-416C-834F-A623261D8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634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3711A3-3D84-E6C1-F202-9DC900A4DA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0E4554-4EFA-F07A-991C-82A3898DBF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5C0DA1-8A3E-771B-B026-AC37DF316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2C8AF7-E539-636E-3BCD-995109C467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564185-9DC3-5B26-836E-3E82CFA32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829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D29CB1-D7B5-F492-D023-DFFFBB2EE8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FBE42C-5C98-2C0C-E889-29404F41BD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E3E6AE-29E6-6EA2-3BE0-A066B29493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C0091B-E266-F328-8D2A-5364EE7841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A98BE2-17E5-5309-524A-2343DA3B5C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B749EA-5554-1990-9F37-874D6B55C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426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F8010C-AB1E-3186-FDA3-CFBFB52611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0A1790-7D64-869F-548F-9D535CBA1D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54C906-FACD-924C-4C11-59DF6BBFEC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04D954D-9DBB-A40C-E6DA-1B6DF67AEF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3515BE5-973D-7E48-1756-058DB4E3E6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705819-296C-B668-8A71-9730AFEBB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DCE8B0F-6C94-3E80-A507-0429C2D83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149D206-E6E3-0B18-5F14-3B682158E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962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8A26E7-C820-026F-EA46-6ED6081E3C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1E5520-019D-6CD2-5D3C-48E67933C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67A4DC-F751-A564-FB1F-78CF15A46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979F2E-693C-27B8-776C-6E4D87C1A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121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74E2CDD-4A1F-B453-882F-827735821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EED2F7F-BF98-21FB-1840-FF0F1B81B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006FC8-EB27-7C8C-1841-B4A7DC38B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119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F25929-BAB8-46E0-70F7-118F9C5825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83A3BB-2A9C-5801-7A8D-BD6661F09D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943C7C-D624-C1E0-0830-8ADF447860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BF718C-FD13-3FFC-0AE5-CDE9C60EF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C431CC-8D56-D7B2-1357-6CFDFA00B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D0559F-5B7A-4CAA-07ED-CABFC5D7F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957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E7EFD7-950E-E05B-31C4-0FD2849B66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625B9D7-54A9-B8EB-7A21-29132BAA31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234C95-85E1-592F-CE46-47AE598B48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D74F9C-1AAB-4B77-6F0A-8E89A8848E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5CFC22-20A3-84A2-D417-E5B3B3794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B9FF56-8166-6FC9-B472-2B9CF315BA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259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6649F1-ED04-C563-4E5B-5767DD2116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99CE23-66AB-A4D0-1EC1-43221ED415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19C18C-2B36-8DBD-71FB-BEFE462BC1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B0C341-EB21-4285-99AF-D888CFCC7DB5}" type="datetimeFigureOut">
              <a:rPr lang="en-US" smtClean="0"/>
              <a:t>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B634DA-39A7-6430-C288-D1E18EFF19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B7F9F7-7FA6-C033-A836-BB4E25C2CE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BDCC1-0B5C-419A-96CE-54BBC51A1F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808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362886-0641-E32B-1E26-576C84C66F8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>
            <a:extLst>
              <a:ext uri="{FF2B5EF4-FFF2-40B4-BE49-F238E27FC236}">
                <a16:creationId xmlns:a16="http://schemas.microsoft.com/office/drawing/2014/main" id="{A4CC12CF-249B-0EBC-0B71-4F4AFDB3A9DD}"/>
              </a:ext>
            </a:extLst>
          </p:cNvPr>
          <p:cNvGrpSpPr/>
          <p:nvPr/>
        </p:nvGrpSpPr>
        <p:grpSpPr>
          <a:xfrm>
            <a:off x="-71189" y="1844131"/>
            <a:ext cx="12061187" cy="5060413"/>
            <a:chOff x="-71189" y="1844131"/>
            <a:chExt cx="12061187" cy="5060413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2C9EF06C-8A1B-82DC-D8FD-12C96443C776}"/>
                </a:ext>
              </a:extLst>
            </p:cNvPr>
            <p:cNvCxnSpPr>
              <a:cxnSpLocks/>
            </p:cNvCxnSpPr>
            <p:nvPr/>
          </p:nvCxnSpPr>
          <p:spPr>
            <a:xfrm>
              <a:off x="7937506" y="3552810"/>
              <a:ext cx="400386" cy="0"/>
            </a:xfrm>
            <a:prstGeom prst="line">
              <a:avLst/>
            </a:prstGeom>
            <a:ln w="38100"/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42A2139-B48B-03FE-F04B-1AE820F8A14E}"/>
                </a:ext>
              </a:extLst>
            </p:cNvPr>
            <p:cNvSpPr txBox="1"/>
            <p:nvPr/>
          </p:nvSpPr>
          <p:spPr>
            <a:xfrm>
              <a:off x="7428193" y="3230021"/>
              <a:ext cx="13877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737 bp</a:t>
              </a:r>
              <a:endParaRPr lang="en-US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92A8B6E-29D2-B33A-2736-BC172EE6CE3D}"/>
                </a:ext>
              </a:extLst>
            </p:cNvPr>
            <p:cNvSpPr txBox="1"/>
            <p:nvPr/>
          </p:nvSpPr>
          <p:spPr>
            <a:xfrm>
              <a:off x="-71189" y="6258213"/>
              <a:ext cx="1206118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b="1" i="0" u="none" strike="noStrike" baseline="0" dirty="0">
                  <a:solidFill>
                    <a:srgbClr val="000000"/>
                  </a:solidFill>
                  <a:latin typeface="Calibri" panose="020F0502020204030204" pitchFamily="34" charset="0"/>
                </a:rPr>
                <a:t>Supplementary Fig. 1. </a:t>
              </a:r>
              <a:r>
                <a:rPr lang="en-US" sz="1800" b="0" i="0" u="none" strike="noStrike" baseline="0" dirty="0">
                  <a:solidFill>
                    <a:srgbClr val="000000"/>
                  </a:solidFill>
                  <a:latin typeface="Calibri" panose="020F0502020204030204" pitchFamily="34" charset="0"/>
                </a:rPr>
                <a:t>Agarose gel electrophoresis of amplicons of positive </a:t>
              </a:r>
              <a:r>
                <a:rPr lang="en-US" sz="1800" b="0" i="1" u="none" strike="noStrike" baseline="0" dirty="0">
                  <a:solidFill>
                    <a:srgbClr val="000000"/>
                  </a:solidFill>
                  <a:latin typeface="Calibri" panose="020F0502020204030204" pitchFamily="34" charset="0"/>
                </a:rPr>
                <a:t>V. alginolyticus </a:t>
              </a:r>
              <a:r>
                <a:rPr lang="en-US" sz="1800" b="0" i="0" u="none" strike="noStrike" baseline="0" dirty="0">
                  <a:solidFill>
                    <a:srgbClr val="000000"/>
                  </a:solidFill>
                  <a:latin typeface="Calibri" panose="020F0502020204030204" pitchFamily="34" charset="0"/>
                </a:rPr>
                <a:t>isolates for collagenase gene 737bp,</a:t>
              </a:r>
            </a:p>
            <a:p>
              <a:r>
                <a:rPr lang="en-US" sz="1800" b="0" i="0" u="none" strike="noStrike" baseline="0" dirty="0">
                  <a:solidFill>
                    <a:srgbClr val="000000"/>
                  </a:solidFill>
                  <a:latin typeface="Calibri" panose="020F0502020204030204" pitchFamily="34" charset="0"/>
                </a:rPr>
                <a:t> Lane M DNA ladder 100 bp, Lane 1,2,3,4 positive </a:t>
              </a:r>
              <a:r>
                <a:rPr lang="en-US" sz="1800" b="0" i="1" u="none" strike="noStrike" baseline="0" dirty="0">
                  <a:solidFill>
                    <a:srgbClr val="000000"/>
                  </a:solidFill>
                  <a:latin typeface="Calibri" panose="020F0502020204030204" pitchFamily="34" charset="0"/>
                </a:rPr>
                <a:t>V. alginolyticus</a:t>
              </a:r>
              <a:r>
                <a:rPr lang="en-US" sz="1800" b="0" i="0" u="none" strike="noStrike" baseline="0" dirty="0">
                  <a:solidFill>
                    <a:srgbClr val="000000"/>
                  </a:solidFill>
                  <a:latin typeface="Calibri" panose="020F0502020204030204" pitchFamily="34" charset="0"/>
                </a:rPr>
                <a:t>. </a:t>
              </a:r>
              <a:endParaRPr lang="en-US" dirty="0"/>
            </a:p>
          </p:txBody>
        </p:sp>
        <p:pic>
          <p:nvPicPr>
            <p:cNvPr id="3" name="Picture 2" descr="A blue and purple background&#10;&#10;Description automatically generated with medium confidence">
              <a:extLst>
                <a:ext uri="{FF2B5EF4-FFF2-40B4-BE49-F238E27FC236}">
                  <a16:creationId xmlns:a16="http://schemas.microsoft.com/office/drawing/2014/main" id="{E42768BA-D9CB-2B6D-4242-095D595C227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39501" y="1889234"/>
              <a:ext cx="3758278" cy="4165506"/>
            </a:xfrm>
            <a:prstGeom prst="rect">
              <a:avLst/>
            </a:prstGeom>
          </p:spPr>
        </p:pic>
        <p:pic>
          <p:nvPicPr>
            <p:cNvPr id="5" name="Picture 4" descr="A blue and pink gradient with dots&#10;&#10;Description automatically generated with medium confidence">
              <a:extLst>
                <a:ext uri="{FF2B5EF4-FFF2-40B4-BE49-F238E27FC236}">
                  <a16:creationId xmlns:a16="http://schemas.microsoft.com/office/drawing/2014/main" id="{337BE347-A143-BBF2-3260-E1DA76D30B9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4582" y="1844131"/>
              <a:ext cx="3316200" cy="4312345"/>
            </a:xfrm>
            <a:prstGeom prst="rect">
              <a:avLst/>
            </a:prstGeom>
          </p:spPr>
        </p:pic>
        <p:pic>
          <p:nvPicPr>
            <p:cNvPr id="7" name="Picture 6" descr="A close-up of a blue screen&#10;&#10;Description automatically generated">
              <a:extLst>
                <a:ext uri="{FF2B5EF4-FFF2-40B4-BE49-F238E27FC236}">
                  <a16:creationId xmlns:a16="http://schemas.microsoft.com/office/drawing/2014/main" id="{0D9822FE-D499-F0DA-192F-99760E50993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85666" y="1889234"/>
              <a:ext cx="3209925" cy="4105275"/>
            </a:xfrm>
            <a:prstGeom prst="rect">
              <a:avLst/>
            </a:prstGeom>
          </p:spPr>
        </p:pic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F5C53BF3-AA09-A985-3B90-062A8F3BA39E}"/>
                </a:ext>
              </a:extLst>
            </p:cNvPr>
            <p:cNvCxnSpPr>
              <a:cxnSpLocks/>
            </p:cNvCxnSpPr>
            <p:nvPr/>
          </p:nvCxnSpPr>
          <p:spPr>
            <a:xfrm>
              <a:off x="12489" y="4237689"/>
              <a:ext cx="894066" cy="0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3C9BD307-086A-03EA-F4B6-B49EC6F5930F}"/>
                </a:ext>
              </a:extLst>
            </p:cNvPr>
            <p:cNvCxnSpPr>
              <a:cxnSpLocks/>
            </p:cNvCxnSpPr>
            <p:nvPr/>
          </p:nvCxnSpPr>
          <p:spPr>
            <a:xfrm>
              <a:off x="4131117" y="4263103"/>
              <a:ext cx="658176" cy="0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1F9D5ED-1A49-8C13-9314-99A35F451B87}"/>
                </a:ext>
              </a:extLst>
            </p:cNvPr>
            <p:cNvSpPr txBox="1"/>
            <p:nvPr/>
          </p:nvSpPr>
          <p:spPr>
            <a:xfrm>
              <a:off x="4074311" y="3850683"/>
              <a:ext cx="9303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737 bp</a:t>
              </a:r>
              <a:endParaRPr lang="en-US" b="1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AB7A13C-8B64-1491-9168-A319FD9E189A}"/>
                </a:ext>
              </a:extLst>
            </p:cNvPr>
            <p:cNvSpPr txBox="1"/>
            <p:nvPr/>
          </p:nvSpPr>
          <p:spPr>
            <a:xfrm>
              <a:off x="1033475" y="1946142"/>
              <a:ext cx="29833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M  1  2 3                          4   M</a:t>
              </a:r>
              <a:endParaRPr lang="en-US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5D4FA8E6-569A-AE27-7E8D-2E9CA52C2401}"/>
                </a:ext>
              </a:extLst>
            </p:cNvPr>
            <p:cNvSpPr txBox="1"/>
            <p:nvPr/>
          </p:nvSpPr>
          <p:spPr>
            <a:xfrm>
              <a:off x="4789293" y="1865194"/>
              <a:ext cx="34624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M  1  2           3 4   M  1 2 3        M</a:t>
              </a:r>
              <a:endParaRPr lang="en-US" dirty="0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D45C9F4-91B4-5CF6-E94F-04B4B483D461}"/>
                </a:ext>
              </a:extLst>
            </p:cNvPr>
            <p:cNvSpPr txBox="1"/>
            <p:nvPr/>
          </p:nvSpPr>
          <p:spPr>
            <a:xfrm>
              <a:off x="8935458" y="2049860"/>
              <a:ext cx="28803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M  1               2                  4  M</a:t>
              </a:r>
              <a:endParaRPr lang="en-US" dirty="0"/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EA55C546-D704-AD9E-63ED-B1603EC6FFC1}"/>
                </a:ext>
              </a:extLst>
            </p:cNvPr>
            <p:cNvCxnSpPr>
              <a:cxnSpLocks/>
            </p:cNvCxnSpPr>
            <p:nvPr/>
          </p:nvCxnSpPr>
          <p:spPr>
            <a:xfrm>
              <a:off x="8337892" y="3612988"/>
              <a:ext cx="597566" cy="1773"/>
            </a:xfrm>
            <a:prstGeom prst="line">
              <a:avLst/>
            </a:prstGeom>
            <a:ln w="571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1696509-B6D7-3030-5355-4619E9B6E193}"/>
                </a:ext>
              </a:extLst>
            </p:cNvPr>
            <p:cNvSpPr txBox="1"/>
            <p:nvPr/>
          </p:nvSpPr>
          <p:spPr>
            <a:xfrm>
              <a:off x="8244968" y="3245429"/>
              <a:ext cx="9303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737 bp</a:t>
              </a:r>
              <a:endParaRPr lang="en-US" b="1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B68B09E-2C2F-9204-0997-E5EF0AD82238}"/>
                </a:ext>
              </a:extLst>
            </p:cNvPr>
            <p:cNvSpPr txBox="1"/>
            <p:nvPr/>
          </p:nvSpPr>
          <p:spPr>
            <a:xfrm>
              <a:off x="12489" y="3874424"/>
              <a:ext cx="13877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737 bp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1640750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101</Words>
  <Application>Microsoft Office PowerPoint</Application>
  <PresentationFormat>Widescreen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an Z. Abd Elhamed Ahmed</dc:creator>
  <cp:lastModifiedBy>Eman Z. Abd Elhamed Ahmed</cp:lastModifiedBy>
  <cp:revision>4</cp:revision>
  <dcterms:created xsi:type="dcterms:W3CDTF">2024-02-09T23:55:45Z</dcterms:created>
  <dcterms:modified xsi:type="dcterms:W3CDTF">2024-02-15T20:14:20Z</dcterms:modified>
</cp:coreProperties>
</file>